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97" r:id="rId5"/>
    <p:sldId id="298" r:id="rId6"/>
    <p:sldId id="257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1" d="100"/>
          <a:sy n="121" d="100"/>
        </p:scale>
        <p:origin x="1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microsoft.com/office/2016/11/relationships/changesInfo" Target="changesInfos/changesInfo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copo Boni" userId="3468928e-f576-476d-811b-ea8091bad45a" providerId="ADAL" clId="{A57800CA-4072-4B01-99D3-B58C761CB754}"/>
    <pc:docChg chg="undo custSel addSld delSld modSld">
      <pc:chgData name="Jacopo Boni" userId="3468928e-f576-476d-811b-ea8091bad45a" providerId="ADAL" clId="{A57800CA-4072-4B01-99D3-B58C761CB754}" dt="2025-07-25T13:30:17.809" v="327" actId="14100"/>
      <pc:docMkLst>
        <pc:docMk/>
      </pc:docMkLst>
      <pc:sldChg chg="modSp mod">
        <pc:chgData name="Jacopo Boni" userId="3468928e-f576-476d-811b-ea8091bad45a" providerId="ADAL" clId="{A57800CA-4072-4B01-99D3-B58C761CB754}" dt="2025-07-25T13:11:22.803" v="181" actId="14100"/>
        <pc:sldMkLst>
          <pc:docMk/>
          <pc:sldMk cId="1899656772" sldId="257"/>
        </pc:sldMkLst>
      </pc:sldChg>
      <pc:sldChg chg="addSp delSp modSp mod">
        <pc:chgData name="Jacopo Boni" userId="3468928e-f576-476d-811b-ea8091bad45a" providerId="ADAL" clId="{A57800CA-4072-4B01-99D3-B58C761CB754}" dt="2025-07-25T12:33:10.854" v="113" actId="732"/>
        <pc:sldMkLst>
          <pc:docMk/>
          <pc:sldMk cId="849156004" sldId="276"/>
        </pc:sldMkLst>
      </pc:sldChg>
      <pc:sldChg chg="addSp modSp mod">
        <pc:chgData name="Jacopo Boni" userId="3468928e-f576-476d-811b-ea8091bad45a" providerId="ADAL" clId="{A57800CA-4072-4B01-99D3-B58C761CB754}" dt="2025-07-25T13:27:02.726" v="320" actId="1076"/>
        <pc:sldMkLst>
          <pc:docMk/>
          <pc:sldMk cId="989154112" sldId="278"/>
        </pc:sldMkLst>
      </pc:sldChg>
      <pc:sldChg chg="addSp delSp modSp mod">
        <pc:chgData name="Jacopo Boni" userId="3468928e-f576-476d-811b-ea8091bad45a" providerId="ADAL" clId="{A57800CA-4072-4B01-99D3-B58C761CB754}" dt="2025-07-25T13:30:17.809" v="327" actId="14100"/>
        <pc:sldMkLst>
          <pc:docMk/>
          <pc:sldMk cId="1574192415" sldId="279"/>
        </pc:sldMkLst>
      </pc:sldChg>
      <pc:sldChg chg="addSp delSp modSp add del mod">
        <pc:chgData name="Jacopo Boni" userId="3468928e-f576-476d-811b-ea8091bad45a" providerId="ADAL" clId="{A57800CA-4072-4B01-99D3-B58C761CB754}" dt="2025-07-25T12:51:25.652" v="163" actId="478"/>
        <pc:sldMkLst>
          <pc:docMk/>
          <pc:sldMk cId="2685193683" sldId="282"/>
        </pc:sldMkLst>
      </pc:sldChg>
      <pc:sldChg chg="addSp modSp add del mod">
        <pc:chgData name="Jacopo Boni" userId="3468928e-f576-476d-811b-ea8091bad45a" providerId="ADAL" clId="{A57800CA-4072-4B01-99D3-B58C761CB754}" dt="2025-07-25T12:56:35.608" v="175" actId="1076"/>
        <pc:sldMkLst>
          <pc:docMk/>
          <pc:sldMk cId="3959166534" sldId="283"/>
        </pc:sldMkLst>
      </pc:sldChg>
      <pc:sldChg chg="addSp delSp modSp mod">
        <pc:chgData name="Jacopo Boni" userId="3468928e-f576-476d-811b-ea8091bad45a" providerId="ADAL" clId="{A57800CA-4072-4B01-99D3-B58C761CB754}" dt="2025-07-25T12:30:28.818" v="82" actId="478"/>
        <pc:sldMkLst>
          <pc:docMk/>
          <pc:sldMk cId="2388881966" sldId="286"/>
        </pc:sldMkLst>
      </pc:sldChg>
      <pc:sldChg chg="delSp modSp mod">
        <pc:chgData name="Jacopo Boni" userId="3468928e-f576-476d-811b-ea8091bad45a" providerId="ADAL" clId="{A57800CA-4072-4B01-99D3-B58C761CB754}" dt="2025-07-25T12:30:35.389" v="84" actId="478"/>
        <pc:sldMkLst>
          <pc:docMk/>
          <pc:sldMk cId="3491293808" sldId="292"/>
        </pc:sldMkLst>
      </pc:sldChg>
      <pc:sldChg chg="delSp mod">
        <pc:chgData name="Jacopo Boni" userId="3468928e-f576-476d-811b-ea8091bad45a" providerId="ADAL" clId="{A57800CA-4072-4B01-99D3-B58C761CB754}" dt="2025-07-25T12:30:33.021" v="83" actId="478"/>
        <pc:sldMkLst>
          <pc:docMk/>
          <pc:sldMk cId="1938919551" sldId="293"/>
        </pc:sldMkLst>
      </pc:sldChg>
      <pc:sldChg chg="delSp modSp mod">
        <pc:chgData name="Jacopo Boni" userId="3468928e-f576-476d-811b-ea8091bad45a" providerId="ADAL" clId="{A57800CA-4072-4B01-99D3-B58C761CB754}" dt="2025-07-25T12:30:43.190" v="85" actId="478"/>
        <pc:sldMkLst>
          <pc:docMk/>
          <pc:sldMk cId="2278150265" sldId="294"/>
        </pc:sldMkLst>
      </pc:sldChg>
      <pc:sldChg chg="addSp delSp modSp add mod">
        <pc:chgData name="Jacopo Boni" userId="3468928e-f576-476d-811b-ea8091bad45a" providerId="ADAL" clId="{A57800CA-4072-4B01-99D3-B58C761CB754}" dt="2025-07-25T12:56:18.031" v="174" actId="14100"/>
        <pc:sldMkLst>
          <pc:docMk/>
          <pc:sldMk cId="1510078259" sldId="299"/>
        </pc:sldMkLst>
      </pc:sldChg>
      <pc:sldChg chg="addSp delSp modSp add mod">
        <pc:chgData name="Jacopo Boni" userId="3468928e-f576-476d-811b-ea8091bad45a" providerId="ADAL" clId="{A57800CA-4072-4B01-99D3-B58C761CB754}" dt="2025-07-25T12:54:58.422" v="169" actId="14100"/>
        <pc:sldMkLst>
          <pc:docMk/>
          <pc:sldMk cId="1256841142" sldId="300"/>
        </pc:sldMkLst>
      </pc:sldChg>
      <pc:sldChg chg="addSp delSp modSp add mod">
        <pc:chgData name="Jacopo Boni" userId="3468928e-f576-476d-811b-ea8091bad45a" providerId="ADAL" clId="{A57800CA-4072-4B01-99D3-B58C761CB754}" dt="2025-07-25T13:17:18.484" v="257" actId="1076"/>
        <pc:sldMkLst>
          <pc:docMk/>
          <pc:sldMk cId="1296663075" sldId="301"/>
        </pc:sldMkLst>
      </pc:sldChg>
      <pc:sldChg chg="delSp modSp add mod">
        <pc:chgData name="Jacopo Boni" userId="3468928e-f576-476d-811b-ea8091bad45a" providerId="ADAL" clId="{A57800CA-4072-4B01-99D3-B58C761CB754}" dt="2025-07-25T13:16:46.474" v="250" actId="1035"/>
        <pc:sldMkLst>
          <pc:docMk/>
          <pc:sldMk cId="2571517090" sldId="302"/>
        </pc:sldMkLst>
      </pc:sldChg>
      <pc:sldChg chg="addSp delSp modSp add mod">
        <pc:chgData name="Jacopo Boni" userId="3468928e-f576-476d-811b-ea8091bad45a" providerId="ADAL" clId="{A57800CA-4072-4B01-99D3-B58C761CB754}" dt="2025-07-25T13:25:08.855" v="294" actId="1076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A25DEC5B-0D96-964B-8538-CEEE1D0657B9}"/>
    <pc:docChg chg="modSld">
      <pc:chgData name="Míriam Fernández González" userId="S::mfernandez@idibell.cat::352a0393-308e-4058-8495-78b481706071" providerId="AD" clId="Web-{A25DEC5B-0D96-964B-8538-CEEE1D0657B9}" dt="2025-07-24T14:40:25.906" v="11"/>
      <pc:docMkLst>
        <pc:docMk/>
      </pc:docMkLst>
      <pc:sldChg chg="delSp modSp">
        <pc:chgData name="Míriam Fernández González" userId="S::mfernandez@idibell.cat::352a0393-308e-4058-8495-78b481706071" providerId="AD" clId="Web-{A25DEC5B-0D96-964B-8538-CEEE1D0657B9}" dt="2025-07-24T14:40:15.109" v="5" actId="20577"/>
        <pc:sldMkLst>
          <pc:docMk/>
          <pc:sldMk cId="989154112" sldId="278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09.328" v="2" actId="20577"/>
        <pc:sldMkLst>
          <pc:docMk/>
          <pc:sldMk cId="1574192415" sldId="279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0.016" v="8" actId="20577"/>
        <pc:sldMkLst>
          <pc:docMk/>
          <pc:sldMk cId="2685193683" sldId="282"/>
        </pc:sldMkLst>
      </pc:sldChg>
      <pc:sldChg chg="delSp modSp">
        <pc:chgData name="Míriam Fernández González" userId="S::mfernandez@idibell.cat::352a0393-308e-4058-8495-78b481706071" providerId="AD" clId="Web-{A25DEC5B-0D96-964B-8538-CEEE1D0657B9}" dt="2025-07-24T14:40:25.906" v="11"/>
        <pc:sldMkLst>
          <pc:docMk/>
          <pc:sldMk cId="3959166534" sldId="283"/>
        </pc:sldMkLst>
      </pc:sldChg>
    </pc:docChg>
  </pc:docChgLst>
  <pc:docChgLst>
    <pc:chgData clId="Web-{2078CF52-1543-3A94-1FF6-FDE5A1C808B6}"/>
    <pc:docChg chg="addSld">
      <pc:chgData name="" userId="" providerId="" clId="Web-{2078CF52-1543-3A94-1FF6-FDE5A1C808B6}" dt="2025-07-25T12:42:52.619" v="0"/>
      <pc:docMkLst>
        <pc:docMk/>
      </pc:docMkLst>
      <pc:sldChg chg="add replId">
        <pc:chgData name="" userId="" providerId="" clId="Web-{2078CF52-1543-3A94-1FF6-FDE5A1C808B6}" dt="2025-07-25T12:42:52.619" v="0"/>
        <pc:sldMkLst>
          <pc:docMk/>
          <pc:sldMk cId="3846821981" sldId="297"/>
        </pc:sldMkLst>
      </pc:sldChg>
    </pc:docChg>
  </pc:docChgLst>
  <pc:docChgLst>
    <pc:chgData name="Míriam Fernández González" userId="352a0393-308e-4058-8495-78b481706071" providerId="ADAL" clId="{6CC23B6F-D564-426D-940C-C35F10A92CC4}"/>
    <pc:docChg chg="undo custSel addSld delSld modSld sldOrd">
      <pc:chgData name="Míriam Fernández González" userId="352a0393-308e-4058-8495-78b481706071" providerId="ADAL" clId="{6CC23B6F-D564-426D-940C-C35F10A92CC4}" dt="2025-07-25T13:42:06.046" v="1944" actId="20577"/>
      <pc:docMkLst>
        <pc:docMk/>
      </pc:docMkLst>
      <pc:sldChg chg="del">
        <pc:chgData name="Míriam Fernández González" userId="352a0393-308e-4058-8495-78b481706071" providerId="ADAL" clId="{6CC23B6F-D564-426D-940C-C35F10A92CC4}" dt="2025-07-23T10:06:54.583" v="1" actId="47"/>
        <pc:sldMkLst>
          <pc:docMk/>
          <pc:sldMk cId="2406273178" sldId="256"/>
        </pc:sldMkLst>
      </pc:sldChg>
      <pc:sldChg chg="addSp delSp modSp new mod">
        <pc:chgData name="Míriam Fernández González" userId="352a0393-308e-4058-8495-78b481706071" providerId="ADAL" clId="{6CC23B6F-D564-426D-940C-C35F10A92CC4}" dt="2025-07-25T12:48:25.066" v="1673" actId="1076"/>
        <pc:sldMkLst>
          <pc:docMk/>
          <pc:sldMk cId="1899656772" sldId="257"/>
        </pc:sldMkLst>
      </pc:sldChg>
      <pc:sldChg chg="add del">
        <pc:chgData name="Míriam Fernández González" userId="352a0393-308e-4058-8495-78b481706071" providerId="ADAL" clId="{6CC23B6F-D564-426D-940C-C35F10A92CC4}" dt="2025-07-23T10:08:25.607" v="29" actId="47"/>
        <pc:sldMkLst>
          <pc:docMk/>
          <pc:sldMk cId="4080752078" sldId="258"/>
        </pc:sldMkLst>
      </pc:sldChg>
      <pc:sldChg chg="add del">
        <pc:chgData name="Míriam Fernández González" userId="352a0393-308e-4058-8495-78b481706071" providerId="ADAL" clId="{6CC23B6F-D564-426D-940C-C35F10A92CC4}" dt="2025-07-23T10:08:26.158" v="30" actId="47"/>
        <pc:sldMkLst>
          <pc:docMk/>
          <pc:sldMk cId="3580857271" sldId="259"/>
        </pc:sldMkLst>
      </pc:sldChg>
      <pc:sldChg chg="add del">
        <pc:chgData name="Míriam Fernández González" userId="352a0393-308e-4058-8495-78b481706071" providerId="ADAL" clId="{6CC23B6F-D564-426D-940C-C35F10A92CC4}" dt="2025-07-23T10:08:26.661" v="31" actId="47"/>
        <pc:sldMkLst>
          <pc:docMk/>
          <pc:sldMk cId="2234829343" sldId="260"/>
        </pc:sldMkLst>
      </pc:sldChg>
      <pc:sldChg chg="add del">
        <pc:chgData name="Míriam Fernández González" userId="352a0393-308e-4058-8495-78b481706071" providerId="ADAL" clId="{6CC23B6F-D564-426D-940C-C35F10A92CC4}" dt="2025-07-23T10:08:26.959" v="32" actId="47"/>
        <pc:sldMkLst>
          <pc:docMk/>
          <pc:sldMk cId="862921727" sldId="261"/>
        </pc:sldMkLst>
      </pc:sldChg>
      <pc:sldChg chg="add del">
        <pc:chgData name="Míriam Fernández González" userId="352a0393-308e-4058-8495-78b481706071" providerId="ADAL" clId="{6CC23B6F-D564-426D-940C-C35F10A92CC4}" dt="2025-07-23T10:08:27.211" v="33" actId="47"/>
        <pc:sldMkLst>
          <pc:docMk/>
          <pc:sldMk cId="3804607996" sldId="262"/>
        </pc:sldMkLst>
      </pc:sldChg>
      <pc:sldChg chg="add del">
        <pc:chgData name="Míriam Fernández González" userId="352a0393-308e-4058-8495-78b481706071" providerId="ADAL" clId="{6CC23B6F-D564-426D-940C-C35F10A92CC4}" dt="2025-07-23T10:08:27.431" v="34" actId="47"/>
        <pc:sldMkLst>
          <pc:docMk/>
          <pc:sldMk cId="4226813653" sldId="263"/>
        </pc:sldMkLst>
      </pc:sldChg>
      <pc:sldChg chg="add del">
        <pc:chgData name="Míriam Fernández González" userId="352a0393-308e-4058-8495-78b481706071" providerId="ADAL" clId="{6CC23B6F-D564-426D-940C-C35F10A92CC4}" dt="2025-07-23T10:08:27.626" v="35" actId="47"/>
        <pc:sldMkLst>
          <pc:docMk/>
          <pc:sldMk cId="1753621800" sldId="264"/>
        </pc:sldMkLst>
      </pc:sldChg>
      <pc:sldChg chg="add del">
        <pc:chgData name="Míriam Fernández González" userId="352a0393-308e-4058-8495-78b481706071" providerId="ADAL" clId="{6CC23B6F-D564-426D-940C-C35F10A92CC4}" dt="2025-07-23T10:08:27.807" v="36" actId="47"/>
        <pc:sldMkLst>
          <pc:docMk/>
          <pc:sldMk cId="3900698960" sldId="265"/>
        </pc:sldMkLst>
      </pc:sldChg>
      <pc:sldChg chg="add del">
        <pc:chgData name="Míriam Fernández González" userId="352a0393-308e-4058-8495-78b481706071" providerId="ADAL" clId="{6CC23B6F-D564-426D-940C-C35F10A92CC4}" dt="2025-07-23T10:08:27.980" v="37" actId="47"/>
        <pc:sldMkLst>
          <pc:docMk/>
          <pc:sldMk cId="2255315707" sldId="266"/>
        </pc:sldMkLst>
      </pc:sldChg>
      <pc:sldChg chg="add del">
        <pc:chgData name="Míriam Fernández González" userId="352a0393-308e-4058-8495-78b481706071" providerId="ADAL" clId="{6CC23B6F-D564-426D-940C-C35F10A92CC4}" dt="2025-07-23T10:08:28.184" v="38" actId="47"/>
        <pc:sldMkLst>
          <pc:docMk/>
          <pc:sldMk cId="1476492493" sldId="267"/>
        </pc:sldMkLst>
      </pc:sldChg>
      <pc:sldChg chg="add del">
        <pc:chgData name="Míriam Fernández González" userId="352a0393-308e-4058-8495-78b481706071" providerId="ADAL" clId="{6CC23B6F-D564-426D-940C-C35F10A92CC4}" dt="2025-07-23T10:08:28.466" v="39" actId="47"/>
        <pc:sldMkLst>
          <pc:docMk/>
          <pc:sldMk cId="835741156" sldId="268"/>
        </pc:sldMkLst>
      </pc:sldChg>
      <pc:sldChg chg="add del">
        <pc:chgData name="Míriam Fernández González" userId="352a0393-308e-4058-8495-78b481706071" providerId="ADAL" clId="{6CC23B6F-D564-426D-940C-C35F10A92CC4}" dt="2025-07-23T10:08:29.142" v="40" actId="47"/>
        <pc:sldMkLst>
          <pc:docMk/>
          <pc:sldMk cId="1533935708" sldId="269"/>
        </pc:sldMkLst>
      </pc:sldChg>
      <pc:sldChg chg="add del ord">
        <pc:chgData name="Míriam Fernández González" userId="352a0393-308e-4058-8495-78b481706071" providerId="ADAL" clId="{6CC23B6F-D564-426D-940C-C35F10A92CC4}" dt="2025-07-23T10:08:22.656" v="28" actId="47"/>
        <pc:sldMkLst>
          <pc:docMk/>
          <pc:sldMk cId="3361930825" sldId="270"/>
        </pc:sldMkLst>
      </pc:sldChg>
      <pc:sldChg chg="add del">
        <pc:chgData name="Míriam Fernández González" userId="352a0393-308e-4058-8495-78b481706071" providerId="ADAL" clId="{6CC23B6F-D564-426D-940C-C35F10A92CC4}" dt="2025-07-23T10:08:18.413" v="25" actId="47"/>
        <pc:sldMkLst>
          <pc:docMk/>
          <pc:sldMk cId="234280666" sldId="271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8:24.392" v="1505" actId="1076"/>
        <pc:sldMkLst>
          <pc:docMk/>
          <pc:sldMk cId="2286362297" sldId="272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05.490" v="402" actId="1076"/>
        <pc:sldMkLst>
          <pc:docMk/>
          <pc:sldMk cId="3604231316" sldId="273"/>
        </pc:sldMkLst>
      </pc:sldChg>
      <pc:sldChg chg="addSp delSp modSp add mod">
        <pc:chgData name="Míriam Fernández González" userId="352a0393-308e-4058-8495-78b481706071" providerId="ADAL" clId="{6CC23B6F-D564-426D-940C-C35F10A92CC4}" dt="2025-07-23T10:25:37.465" v="407" actId="1076"/>
        <pc:sldMkLst>
          <pc:docMk/>
          <pc:sldMk cId="2525473906" sldId="274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9:09.219" v="1514" actId="1076"/>
        <pc:sldMkLst>
          <pc:docMk/>
          <pc:sldMk cId="98097563" sldId="275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42:06.046" v="1944" actId="20577"/>
        <pc:sldMkLst>
          <pc:docMk/>
          <pc:sldMk cId="849156004" sldId="276"/>
        </pc:sldMkLst>
      </pc:sldChg>
      <pc:sldChg chg="addSp modSp add mod ord">
        <pc:chgData name="Míriam Fernández González" userId="352a0393-308e-4058-8495-78b481706071" providerId="ADAL" clId="{6CC23B6F-D564-426D-940C-C35F10A92CC4}" dt="2025-07-23T15:10:13.896" v="1530" actId="732"/>
        <pc:sldMkLst>
          <pc:docMk/>
          <pc:sldMk cId="631989269" sldId="277"/>
        </pc:sldMkLst>
      </pc:sldChg>
      <pc:sldChg chg="add del">
        <pc:chgData name="Míriam Fernández González" userId="352a0393-308e-4058-8495-78b481706071" providerId="ADAL" clId="{6CC23B6F-D564-426D-940C-C35F10A92CC4}" dt="2025-07-23T10:28:22.542" v="472" actId="47"/>
        <pc:sldMkLst>
          <pc:docMk/>
          <pc:sldMk cId="1700075419" sldId="27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6:16.325" v="1797" actId="1076"/>
        <pc:sldMkLst>
          <pc:docMk/>
          <pc:sldMk cId="989154112" sldId="278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5:38.084" v="1784" actId="1076"/>
        <pc:sldMkLst>
          <pc:docMk/>
          <pc:sldMk cId="1574192415" sldId="279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03.884" v="1543" actId="1076"/>
        <pc:sldMkLst>
          <pc:docMk/>
          <pc:sldMk cId="3766750973" sldId="280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11:18.375" v="1546" actId="1076"/>
        <pc:sldMkLst>
          <pc:docMk/>
          <pc:sldMk cId="3324629129" sldId="28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5T13:38:08.500" v="1887" actId="1076"/>
        <pc:sldMkLst>
          <pc:docMk/>
          <pc:sldMk cId="2685193683" sldId="282"/>
        </pc:sldMkLst>
      </pc:sldChg>
      <pc:sldChg chg="add del">
        <pc:chgData name="Míriam Fernández González" userId="352a0393-308e-4058-8495-78b481706071" providerId="ADAL" clId="{6CC23B6F-D564-426D-940C-C35F10A92CC4}" dt="2025-07-23T10:40:15.154" v="784" actId="47"/>
        <pc:sldMkLst>
          <pc:docMk/>
          <pc:sldMk cId="3650244235" sldId="282"/>
        </pc:sldMkLst>
      </pc:sldChg>
      <pc:sldChg chg="addSp delSp modSp add mod">
        <pc:chgData name="Míriam Fernández González" userId="352a0393-308e-4058-8495-78b481706071" providerId="ADAL" clId="{6CC23B6F-D564-426D-940C-C35F10A92CC4}" dt="2025-07-25T13:38:50.567" v="1898" actId="14100"/>
        <pc:sldMkLst>
          <pc:docMk/>
          <pc:sldMk cId="3959166534" sldId="28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6:28.343" v="1488" actId="1076"/>
        <pc:sldMkLst>
          <pc:docMk/>
          <pc:sldMk cId="640523941" sldId="284"/>
        </pc:sldMkLst>
      </pc:sldChg>
      <pc:sldChg chg="addSp delSp modSp add del mod">
        <pc:chgData name="Míriam Fernández González" userId="352a0393-308e-4058-8495-78b481706071" providerId="ADAL" clId="{6CC23B6F-D564-426D-940C-C35F10A92CC4}" dt="2025-07-23T11:07:57.119" v="1087" actId="47"/>
        <pc:sldMkLst>
          <pc:docMk/>
          <pc:sldMk cId="2552082302" sldId="285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15.365" v="1494" actId="1076"/>
        <pc:sldMkLst>
          <pc:docMk/>
          <pc:sldMk cId="2388881966" sldId="286"/>
        </pc:sldMkLst>
      </pc:sldChg>
      <pc:sldChg chg="delSp modSp add del mod">
        <pc:chgData name="Míriam Fernández González" userId="352a0393-308e-4058-8495-78b481706071" providerId="ADAL" clId="{6CC23B6F-D564-426D-940C-C35F10A92CC4}" dt="2025-07-23T11:09:33.386" v="1121" actId="47"/>
        <pc:sldMkLst>
          <pc:docMk/>
          <pc:sldMk cId="872468030" sldId="287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6:34.939" v="1490" actId="1076"/>
        <pc:sldMkLst>
          <pc:docMk/>
          <pc:sldMk cId="1854992774" sldId="288"/>
        </pc:sldMkLst>
      </pc:sldChg>
      <pc:sldChg chg="delSp modSp add del mod">
        <pc:chgData name="Míriam Fernández González" userId="352a0393-308e-4058-8495-78b481706071" providerId="ADAL" clId="{6CC23B6F-D564-426D-940C-C35F10A92CC4}" dt="2025-07-23T14:58:21.220" v="1349" actId="47"/>
        <pc:sldMkLst>
          <pc:docMk/>
          <pc:sldMk cId="944466747" sldId="289"/>
        </pc:sldMkLst>
      </pc:sldChg>
      <pc:sldChg chg="delSp modSp add del mod">
        <pc:chgData name="Míriam Fernández González" userId="352a0393-308e-4058-8495-78b481706071" providerId="ADAL" clId="{6CC23B6F-D564-426D-940C-C35F10A92CC4}" dt="2025-07-23T11:17:00.464" v="1307" actId="47"/>
        <pc:sldMkLst>
          <pc:docMk/>
          <pc:sldMk cId="699899518" sldId="290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42.025" v="1498" actId="14100"/>
        <pc:sldMkLst>
          <pc:docMk/>
          <pc:sldMk cId="3714277399" sldId="291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7:55.238" v="1499"/>
        <pc:sldMkLst>
          <pc:docMk/>
          <pc:sldMk cId="3491293808" sldId="292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26.903" v="1496" actId="1076"/>
        <pc:sldMkLst>
          <pc:docMk/>
          <pc:sldMk cId="1938919551" sldId="293"/>
        </pc:sldMkLst>
      </pc:sldChg>
      <pc:sldChg chg="addSp delSp modSp add mod">
        <pc:chgData name="Míriam Fernández González" userId="352a0393-308e-4058-8495-78b481706071" providerId="ADAL" clId="{6CC23B6F-D564-426D-940C-C35F10A92CC4}" dt="2025-07-23T15:07:57.744" v="1500"/>
        <pc:sldMkLst>
          <pc:docMk/>
          <pc:sldMk cId="2278150265" sldId="294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08.012" v="1501"/>
        <pc:sldMkLst>
          <pc:docMk/>
          <pc:sldMk cId="3333836771" sldId="295"/>
        </pc:sldMkLst>
      </pc:sldChg>
      <pc:sldChg chg="addSp delSp modSp add mod ord">
        <pc:chgData name="Míriam Fernández González" userId="352a0393-308e-4058-8495-78b481706071" providerId="ADAL" clId="{6CC23B6F-D564-426D-940C-C35F10A92CC4}" dt="2025-07-23T15:08:10.319" v="1502"/>
        <pc:sldMkLst>
          <pc:docMk/>
          <pc:sldMk cId="3104352323" sldId="296"/>
        </pc:sldMkLst>
      </pc:sldChg>
      <pc:sldChg chg="addSp delSp modSp new del mod">
        <pc:chgData name="Míriam Fernández González" userId="352a0393-308e-4058-8495-78b481706071" providerId="ADAL" clId="{6CC23B6F-D564-426D-940C-C35F10A92CC4}" dt="2025-07-23T15:02:36.537" v="1431" actId="47"/>
        <pc:sldMkLst>
          <pc:docMk/>
          <pc:sldMk cId="479128856" sldId="297"/>
        </pc:sldMkLst>
      </pc:sldChg>
      <pc:sldChg chg="addSp modSp mod">
        <pc:chgData name="Míriam Fernández González" userId="352a0393-308e-4058-8495-78b481706071" providerId="ADAL" clId="{6CC23B6F-D564-426D-940C-C35F10A92CC4}" dt="2025-07-25T12:48:07.213" v="1669" actId="1076"/>
        <pc:sldMkLst>
          <pc:docMk/>
          <pc:sldMk cId="3846821981" sldId="297"/>
        </pc:sldMkLst>
      </pc:sldChg>
      <pc:sldChg chg="addSp delSp modSp mod">
        <pc:chgData name="Míriam Fernández González" userId="352a0393-308e-4058-8495-78b481706071" providerId="ADAL" clId="{6CC23B6F-D564-426D-940C-C35F10A92CC4}" dt="2025-07-25T12:48:34.066" v="1678" actId="1036"/>
        <pc:sldMkLst>
          <pc:docMk/>
          <pc:sldMk cId="3507912059" sldId="298"/>
        </pc:sldMkLst>
      </pc:sldChg>
      <pc:sldChg chg="addSp delSp modSp mod">
        <pc:chgData name="Míriam Fernández González" userId="352a0393-308e-4058-8495-78b481706071" providerId="ADAL" clId="{6CC23B6F-D564-426D-940C-C35F10A92CC4}" dt="2025-07-25T13:39:30.415" v="1907" actId="1076"/>
        <pc:sldMkLst>
          <pc:docMk/>
          <pc:sldMk cId="1510078259" sldId="299"/>
        </pc:sldMkLst>
      </pc:sldChg>
      <pc:sldChg chg="addSp delSp modSp mod">
        <pc:chgData name="Míriam Fernández González" userId="352a0393-308e-4058-8495-78b481706071" providerId="ADAL" clId="{6CC23B6F-D564-426D-940C-C35F10A92CC4}" dt="2025-07-25T13:40:05.751" v="1930" actId="1036"/>
        <pc:sldMkLst>
          <pc:docMk/>
          <pc:sldMk cId="1256841142" sldId="300"/>
        </pc:sldMkLst>
      </pc:sldChg>
      <pc:sldChg chg="modSp mod">
        <pc:chgData name="Míriam Fernández González" userId="352a0393-308e-4058-8495-78b481706071" providerId="ADAL" clId="{6CC23B6F-D564-426D-940C-C35F10A92CC4}" dt="2025-07-25T13:33:06.576" v="1682" actId="20577"/>
        <pc:sldMkLst>
          <pc:docMk/>
          <pc:sldMk cId="1296663075" sldId="301"/>
        </pc:sldMkLst>
      </pc:sldChg>
      <pc:sldChg chg="modSp mod">
        <pc:chgData name="Míriam Fernández González" userId="352a0393-308e-4058-8495-78b481706071" providerId="ADAL" clId="{6CC23B6F-D564-426D-940C-C35F10A92CC4}" dt="2025-07-25T13:33:37.413" v="1694" actId="20577"/>
        <pc:sldMkLst>
          <pc:docMk/>
          <pc:sldMk cId="2571517090" sldId="302"/>
        </pc:sldMkLst>
      </pc:sldChg>
      <pc:sldChg chg="modSp mod">
        <pc:chgData name="Míriam Fernández González" userId="352a0393-308e-4058-8495-78b481706071" providerId="ADAL" clId="{6CC23B6F-D564-426D-940C-C35F10A92CC4}" dt="2025-07-25T13:33:26.110" v="1690" actId="20577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98EE4D30-4875-04A6-BF8A-D2A056950045}"/>
    <pc:docChg chg="modSld">
      <pc:chgData name="Míriam Fernández González" userId="S::mfernandez@idibell.cat::352a0393-308e-4058-8495-78b481706071" providerId="AD" clId="Web-{98EE4D30-4875-04A6-BF8A-D2A056950045}" dt="2025-07-25T13:30:24.917" v="14" actId="1076"/>
      <pc:docMkLst>
        <pc:docMk/>
      </pc:docMkLst>
      <pc:sldChg chg="modSp">
        <pc:chgData name="Míriam Fernández González" userId="S::mfernandez@idibell.cat::352a0393-308e-4058-8495-78b481706071" providerId="AD" clId="Web-{98EE4D30-4875-04A6-BF8A-D2A056950045}" dt="2025-07-25T12:54:33.628" v="0" actId="1076"/>
        <pc:sldMkLst>
          <pc:docMk/>
          <pc:sldMk cId="3604231316" sldId="273"/>
        </pc:sldMkLst>
      </pc:sldChg>
      <pc:sldChg chg="addSp delSp modSp">
        <pc:chgData name="Míriam Fernández González" userId="S::mfernandez@idibell.cat::352a0393-308e-4058-8495-78b481706071" providerId="AD" clId="Web-{98EE4D30-4875-04A6-BF8A-D2A056950045}" dt="2025-07-25T13:30:24.917" v="14" actId="1076"/>
        <pc:sldMkLst>
          <pc:docMk/>
          <pc:sldMk cId="2685193683" sldId="282"/>
        </pc:sldMkLst>
      </pc:sldChg>
    </pc:docChg>
  </pc:docChgLst>
  <pc:docChgLst>
    <pc:chgData name="Jacopo Boni" userId="3468928e-f576-476d-811b-ea8091bad45a" providerId="ADAL" clId="{F8328929-8069-4A27-BC10-04899D47FBC5}"/>
    <pc:docChg chg="delSld">
      <pc:chgData name="Jacopo Boni" userId="3468928e-f576-476d-811b-ea8091bad45a" providerId="ADAL" clId="{F8328929-8069-4A27-BC10-04899D47FBC5}" dt="2025-09-08T15:12:13.121" v="2" actId="47"/>
      <pc:docMkLst>
        <pc:docMk/>
      </pc:docMkLst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2286362297" sldId="272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604231316" sldId="273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2525473906" sldId="274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98097563" sldId="275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849156004" sldId="276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631989269" sldId="277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989154112" sldId="278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1574192415" sldId="279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766750973" sldId="280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324629129" sldId="281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2685193683" sldId="282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959166534" sldId="283"/>
        </pc:sldMkLst>
      </pc:sldChg>
      <pc:sldChg chg="del">
        <pc:chgData name="Jacopo Boni" userId="3468928e-f576-476d-811b-ea8091bad45a" providerId="ADAL" clId="{F8328929-8069-4A27-BC10-04899D47FBC5}" dt="2025-09-08T15:12:08.361" v="0" actId="47"/>
        <pc:sldMkLst>
          <pc:docMk/>
          <pc:sldMk cId="640523941" sldId="284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2388881966" sldId="286"/>
        </pc:sldMkLst>
      </pc:sldChg>
      <pc:sldChg chg="del">
        <pc:chgData name="Jacopo Boni" userId="3468928e-f576-476d-811b-ea8091bad45a" providerId="ADAL" clId="{F8328929-8069-4A27-BC10-04899D47FBC5}" dt="2025-09-08T15:12:09.185" v="1" actId="47"/>
        <pc:sldMkLst>
          <pc:docMk/>
          <pc:sldMk cId="1854992774" sldId="288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714277399" sldId="291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491293808" sldId="292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1938919551" sldId="293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2278150265" sldId="294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333836771" sldId="295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104352323" sldId="296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1510078259" sldId="299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1256841142" sldId="300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1296663075" sldId="301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2571517090" sldId="302"/>
        </pc:sldMkLst>
      </pc:sldChg>
      <pc:sldChg chg="del">
        <pc:chgData name="Jacopo Boni" userId="3468928e-f576-476d-811b-ea8091bad45a" providerId="ADAL" clId="{F8328929-8069-4A27-BC10-04899D47FBC5}" dt="2025-09-08T15:12:13.121" v="2" actId="47"/>
        <pc:sldMkLst>
          <pc:docMk/>
          <pc:sldMk cId="3263583077" sldId="303"/>
        </pc:sldMkLst>
      </pc:sldChg>
    </pc:docChg>
  </pc:docChgLst>
  <pc:docChgLst>
    <pc:chgData name="Míriam Fernández González" userId="S::mfernandez@idibell.cat::352a0393-308e-4058-8495-78b481706071" providerId="AD" clId="Web-{2078CF52-1543-3A94-1FF6-FDE5A1C808B6}"/>
    <pc:docChg chg="addSld modSld sldOrd">
      <pc:chgData name="Míriam Fernández González" userId="S::mfernandez@idibell.cat::352a0393-308e-4058-8495-78b481706071" providerId="AD" clId="Web-{2078CF52-1543-3A94-1FF6-FDE5A1C808B6}" dt="2025-07-25T12:43:24.933" v="2"/>
      <pc:docMkLst>
        <pc:docMk/>
      </pc:docMkLst>
      <pc:sldChg chg="addSp modSp ord">
        <pc:chgData name="Míriam Fernández González" userId="S::mfernandez@idibell.cat::352a0393-308e-4058-8495-78b481706071" providerId="AD" clId="Web-{2078CF52-1543-3A94-1FF6-FDE5A1C808B6}" dt="2025-07-25T12:43:24.933" v="2"/>
        <pc:sldMkLst>
          <pc:docMk/>
          <pc:sldMk cId="1899656772" sldId="257"/>
        </pc:sldMkLst>
      </pc:sldChg>
      <pc:sldChg chg="add replId">
        <pc:chgData name="Míriam Fernández González" userId="S::mfernandez@idibell.cat::352a0393-308e-4058-8495-78b481706071" providerId="AD" clId="Web-{2078CF52-1543-3A94-1FF6-FDE5A1C808B6}" dt="2025-07-25T12:42:53.666" v="0"/>
        <pc:sldMkLst>
          <pc:docMk/>
          <pc:sldMk cId="3507912059" sldId="29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8191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1863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5096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174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9700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9029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2394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0658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82375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044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03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771E8B-6CA5-40B2-8038-0E112F3DAC1C}" type="datetimeFigureOut">
              <a:rPr lang="es-ES" smtClean="0"/>
              <a:t>08/09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1556C4-DFC3-4611-A7CC-780699185E2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3118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8E6264A-B2C0-7A77-F11A-E5DF155C3DF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73B1A9C7-2D99-3E82-259A-9ADF0CBD375D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2C</a:t>
            </a:r>
          </a:p>
        </p:txBody>
      </p:sp>
      <p:pic>
        <p:nvPicPr>
          <p:cNvPr id="29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24F8AC2F-2889-1492-5094-F359F5811E6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3342" b="2322"/>
          <a:stretch>
            <a:fillRect/>
          </a:stretch>
        </p:blipFill>
        <p:spPr bwMode="auto">
          <a:xfrm>
            <a:off x="226611" y="1046978"/>
            <a:ext cx="1240160" cy="31109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Imagen 3" descr="Imagen que contiene interior, tabla, computadora, hombre&#10;&#10;El contenido generado por IA puede ser incorrecto.">
            <a:extLst>
              <a:ext uri="{FF2B5EF4-FFF2-40B4-BE49-F238E27FC236}">
                <a16:creationId xmlns:a16="http://schemas.microsoft.com/office/drawing/2014/main" id="{FF8103E7-3841-F9D6-85FC-D3AB98B00B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9932" y="810818"/>
            <a:ext cx="7200000" cy="5236364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136E8EAD-A2B7-7160-A7FA-7CACC34E4257}"/>
              </a:ext>
            </a:extLst>
          </p:cNvPr>
          <p:cNvSpPr/>
          <p:nvPr/>
        </p:nvSpPr>
        <p:spPr>
          <a:xfrm>
            <a:off x="5124659" y="2155181"/>
            <a:ext cx="3802069" cy="577971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88A6261B-A2F0-9B20-8DB2-3FC28EF771BD}"/>
              </a:ext>
            </a:extLst>
          </p:cNvPr>
          <p:cNvSpPr txBox="1"/>
          <p:nvPr/>
        </p:nvSpPr>
        <p:spPr>
          <a:xfrm rot="16200000">
            <a:off x="6575522" y="-172765"/>
            <a:ext cx="994451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Parental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WT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R661P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FFAE8D79-8D84-122E-62DC-766BD6B14CE7}"/>
              </a:ext>
            </a:extLst>
          </p:cNvPr>
          <p:cNvSpPr txBox="1"/>
          <p:nvPr/>
        </p:nvSpPr>
        <p:spPr>
          <a:xfrm>
            <a:off x="10009932" y="2233123"/>
            <a:ext cx="149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FLAG-FGFR1</a:t>
            </a:r>
          </a:p>
        </p:txBody>
      </p:sp>
      <p:pic>
        <p:nvPicPr>
          <p:cNvPr id="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2FA64958-B06F-C77B-BD87-B36195D6903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2728671" y="1614514"/>
            <a:ext cx="1806927" cy="17669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46821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3495F84-B8C2-5D6D-4792-5DAF8EAAEF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C1F74CA9-95D9-A617-F46F-61F25581A8ED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2C</a:t>
            </a:r>
          </a:p>
        </p:txBody>
      </p:sp>
      <p:pic>
        <p:nvPicPr>
          <p:cNvPr id="4" name="Imagen 3" descr="Imagen que contiene interior, tabla, microondas, refrigerador&#10;&#10;El contenido generado por IA puede ser incorrecto.">
            <a:extLst>
              <a:ext uri="{FF2B5EF4-FFF2-40B4-BE49-F238E27FC236}">
                <a16:creationId xmlns:a16="http://schemas.microsoft.com/office/drawing/2014/main" id="{AF4FF477-BCB6-CC26-F765-72229701CD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9303" y="892976"/>
            <a:ext cx="7200000" cy="5236364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6C0CD887-4D41-2232-6779-69DABED86CE3}"/>
              </a:ext>
            </a:extLst>
          </p:cNvPr>
          <p:cNvSpPr/>
          <p:nvPr/>
        </p:nvSpPr>
        <p:spPr>
          <a:xfrm>
            <a:off x="4701965" y="2344962"/>
            <a:ext cx="3802069" cy="577971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89A62B5B-3F07-67CF-4567-2719F421C658}"/>
              </a:ext>
            </a:extLst>
          </p:cNvPr>
          <p:cNvSpPr txBox="1"/>
          <p:nvPr/>
        </p:nvSpPr>
        <p:spPr>
          <a:xfrm rot="16200000">
            <a:off x="6152828" y="17016"/>
            <a:ext cx="994451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Parental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WT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R661P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8BF1D1BF-E446-B22D-E77E-09F7A82B85D7}"/>
              </a:ext>
            </a:extLst>
          </p:cNvPr>
          <p:cNvSpPr txBox="1"/>
          <p:nvPr/>
        </p:nvSpPr>
        <p:spPr>
          <a:xfrm>
            <a:off x="9879303" y="2449281"/>
            <a:ext cx="9994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pFGFR1</a:t>
            </a:r>
          </a:p>
        </p:txBody>
      </p:sp>
      <p:pic>
        <p:nvPicPr>
          <p:cNvPr id="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84CAFC41-E4FC-6635-BB86-49548CEC4FF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19" r="32877" b="61468"/>
          <a:stretch>
            <a:fillRect/>
          </a:stretch>
        </p:blipFill>
        <p:spPr bwMode="auto">
          <a:xfrm>
            <a:off x="2207403" y="1961026"/>
            <a:ext cx="1806927" cy="17669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079120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EFED1B31-A77C-1754-1D89-FD8484C8AF08}"/>
              </a:ext>
            </a:extLst>
          </p:cNvPr>
          <p:cNvSpPr txBox="1"/>
          <p:nvPr/>
        </p:nvSpPr>
        <p:spPr>
          <a:xfrm>
            <a:off x="370936" y="336430"/>
            <a:ext cx="4683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/>
              <a:t>2C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7A526876-80D2-9BFD-DF60-75EEE6CAE5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6076" y="810818"/>
            <a:ext cx="7200000" cy="5236364"/>
          </a:xfrm>
          <a:prstGeom prst="rect">
            <a:avLst/>
          </a:prstGeom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81BBC0CA-7F6A-EDD9-B5E6-88617FFBDA99}"/>
              </a:ext>
            </a:extLst>
          </p:cNvPr>
          <p:cNvSpPr/>
          <p:nvPr/>
        </p:nvSpPr>
        <p:spPr>
          <a:xfrm>
            <a:off x="4477678" y="2931559"/>
            <a:ext cx="3802069" cy="577971"/>
          </a:xfrm>
          <a:prstGeom prst="rect">
            <a:avLst/>
          </a:prstGeom>
          <a:noFill/>
          <a:ln w="381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2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EF0E9A3-023D-78E6-4D62-D0507A0E4FCC}"/>
              </a:ext>
            </a:extLst>
          </p:cNvPr>
          <p:cNvSpPr txBox="1"/>
          <p:nvPr/>
        </p:nvSpPr>
        <p:spPr>
          <a:xfrm rot="16200000">
            <a:off x="5928541" y="388170"/>
            <a:ext cx="994451" cy="36317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Parental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WT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N546K-R661P  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K656E-R661P</a:t>
            </a:r>
          </a:p>
          <a:p>
            <a:pPr>
              <a:spcBef>
                <a:spcPts val="200"/>
              </a:spcBef>
            </a:pPr>
            <a:endParaRPr lang="en-US" sz="1400" b="1">
              <a:solidFill>
                <a:srgbClr val="FF0000"/>
              </a:solidFill>
            </a:endParaRPr>
          </a:p>
          <a:p>
            <a:pPr>
              <a:spcBef>
                <a:spcPts val="200"/>
              </a:spcBef>
            </a:pPr>
            <a:r>
              <a:rPr lang="en-US" sz="1400" b="1">
                <a:solidFill>
                  <a:srgbClr val="FF0000"/>
                </a:solidFill>
              </a:rPr>
              <a:t>R661P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11118AD9-876B-A7D1-1974-5961D5164D96}"/>
              </a:ext>
            </a:extLst>
          </p:cNvPr>
          <p:cNvSpPr txBox="1"/>
          <p:nvPr/>
        </p:nvSpPr>
        <p:spPr>
          <a:xfrm>
            <a:off x="9806076" y="3035878"/>
            <a:ext cx="961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solidFill>
                  <a:srgbClr val="FF0000"/>
                </a:solidFill>
              </a:rPr>
              <a:t>Tubulin</a:t>
            </a:r>
          </a:p>
        </p:txBody>
      </p:sp>
      <p:pic>
        <p:nvPicPr>
          <p:cNvPr id="8" name="Picture 2" descr="Precision Plus Protein™ Dual Xtra Prestained Protein ...">
            <a:extLst>
              <a:ext uri="{FF2B5EF4-FFF2-40B4-BE49-F238E27FC236}">
                <a16:creationId xmlns:a16="http://schemas.microsoft.com/office/drawing/2014/main" id="{F4A0D701-DDC1-8559-EA2B-961108AB4EA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1" t="30711" r="34356" b="32726"/>
          <a:stretch>
            <a:fillRect/>
          </a:stretch>
        </p:blipFill>
        <p:spPr bwMode="auto">
          <a:xfrm>
            <a:off x="1369974" y="2483077"/>
            <a:ext cx="2472204" cy="23916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9965677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3b06b1ac-b6cc-4c25-bfb7-551e20c80d5c">
      <Terms xmlns="http://schemas.microsoft.com/office/infopath/2007/PartnerControls"/>
    </lcf76f155ced4ddcb4097134ff3c332f>
    <_ip_UnifiedCompliancePolicyUIAction xmlns="http://schemas.microsoft.com/sharepoint/v3" xsi:nil="true"/>
    <_ip_UnifiedCompliancePolicyProperties xmlns="http://schemas.microsoft.com/sharepoint/v3" xsi:nil="true"/>
    <experiment xmlns="3b06b1ac-b6cc-4c25-bfb7-551e20c80d5c" xsi:nil="true"/>
    <TaxCatchAll xmlns="e060ecb7-dcf7-4a45-ada8-96d79a1fb1be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82784A8EC112FF47A12A49FA34F89301" ma:contentTypeVersion="19" ma:contentTypeDescription="Crear nuevo documento." ma:contentTypeScope="" ma:versionID="3a523e80048e49ca689ccbbead60cdeb">
  <xsd:schema xmlns:xsd="http://www.w3.org/2001/XMLSchema" xmlns:xs="http://www.w3.org/2001/XMLSchema" xmlns:p="http://schemas.microsoft.com/office/2006/metadata/properties" xmlns:ns1="http://schemas.microsoft.com/sharepoint/v3" xmlns:ns2="3b06b1ac-b6cc-4c25-bfb7-551e20c80d5c" xmlns:ns3="e060ecb7-dcf7-4a45-ada8-96d79a1fb1be" targetNamespace="http://schemas.microsoft.com/office/2006/metadata/properties" ma:root="true" ma:fieldsID="bb7710ec5d278677887808aadfeb7836" ns1:_="" ns2:_="" ns3:_="">
    <xsd:import namespace="http://schemas.microsoft.com/sharepoint/v3"/>
    <xsd:import namespace="3b06b1ac-b6cc-4c25-bfb7-551e20c80d5c"/>
    <xsd:import namespace="e060ecb7-dcf7-4a45-ada8-96d79a1fb1b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MediaServiceDateTaken" minOccurs="0"/>
                <xsd:element ref="ns2:MediaServiceLocatio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3:SharedWithUsers" minOccurs="0"/>
                <xsd:element ref="ns3:SharedWithDetails" minOccurs="0"/>
                <xsd:element ref="ns2:experiment" minOccurs="0"/>
                <xsd:element ref="ns1:_ip_UnifiedCompliancePolicyProperties" minOccurs="0"/>
                <xsd:element ref="ns1:_ip_UnifiedCompliancePolicyUIAction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24" nillable="true" ma:displayName="Propiedades de la Directiva de cumplimiento unificado" ma:hidden="true" ma:internalName="_ip_UnifiedCompliancePolicyProperties">
      <xsd:simpleType>
        <xsd:restriction base="dms:Note"/>
      </xsd:simpleType>
    </xsd:element>
    <xsd:element name="_ip_UnifiedCompliancePolicyUIAction" ma:index="25" nillable="true" ma:displayName="Acción de IU de la Directiva de cumplimiento unificado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06b1ac-b6cc-4c25-bfb7-551e20c80d5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8" nillable="true" ma:taxonomy="true" ma:internalName="lcf76f155ced4ddcb4097134ff3c332f" ma:taxonomyFieldName="MediaServiceImageTags" ma:displayName="Etiquetas de imagen" ma:readOnly="false" ma:fieldId="{5cf76f15-5ced-4ddc-b409-7134ff3c332f}" ma:taxonomyMulti="true" ma:sspId="060dc275-4b37-4471-97cc-e467d34dad9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experiment" ma:index="23" nillable="true" ma:displayName="experiment" ma:format="Dropdown" ma:internalName="experiment">
      <xsd:simpleType>
        <xsd:restriction base="dms:Text">
          <xsd:maxLength value="255"/>
        </xsd:restriction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060ecb7-dcf7-4a45-ada8-96d79a1fb1be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e1f92d22-2900-48ef-9cf0-36df0f5fa8f8}" ma:internalName="TaxCatchAll" ma:showField="CatchAllData" ma:web="e060ecb7-dcf7-4a45-ada8-96d79a1fb1b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F7AEF27-12CF-4E6A-A4C3-0C70AB873B03}">
  <ds:schemaRefs>
    <ds:schemaRef ds:uri="3b06b1ac-b6cc-4c25-bfb7-551e20c80d5c"/>
    <ds:schemaRef ds:uri="e060ecb7-dcf7-4a45-ada8-96d79a1fb1be"/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customXml/itemProps2.xml><?xml version="1.0" encoding="utf-8"?>
<ds:datastoreItem xmlns:ds="http://schemas.openxmlformats.org/officeDocument/2006/customXml" ds:itemID="{19958082-6C40-488A-8135-0A38B0E6EB72}">
  <ds:schemaRefs>
    <ds:schemaRef ds:uri="3b06b1ac-b6cc-4c25-bfb7-551e20c80d5c"/>
    <ds:schemaRef ds:uri="e060ecb7-dcf7-4a45-ada8-96d79a1fb1be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B975D885-2EFD-43D8-9F27-DFF974AB0B7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</TotalTime>
  <Words>27</Words>
  <Application>Microsoft Office PowerPoint</Application>
  <PresentationFormat>Panorámica</PresentationFormat>
  <Paragraphs>45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Jacopo Boni</cp:lastModifiedBy>
  <cp:revision>1</cp:revision>
  <dcterms:created xsi:type="dcterms:W3CDTF">2025-07-23T10:06:09Z</dcterms:created>
  <dcterms:modified xsi:type="dcterms:W3CDTF">2025-09-08T15:12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2784A8EC112FF47A12A49FA34F89301</vt:lpwstr>
  </property>
  <property fmtid="{D5CDD505-2E9C-101B-9397-08002B2CF9AE}" pid="3" name="MediaServiceImageTags">
    <vt:lpwstr/>
  </property>
</Properties>
</file>